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  <a:srgbClr val="008000"/>
    <a:srgbClr val="996600"/>
    <a:srgbClr val="006600"/>
    <a:srgbClr val="990099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4585" autoAdjust="0"/>
  </p:normalViewPr>
  <p:slideViewPr>
    <p:cSldViewPr snapToGrid="0">
      <p:cViewPr>
        <p:scale>
          <a:sx n="80" d="100"/>
          <a:sy n="80" d="100"/>
        </p:scale>
        <p:origin x="-912" y="-5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82" d="100"/>
          <a:sy n="82" d="100"/>
        </p:scale>
        <p:origin x="-3936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A0EE6-1AEB-4320-B071-D9A4A03B3ED2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0A0E9E-2ACA-44AD-BEF1-031FA851C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1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9E469-D60F-4038-B20E-723A0D3FB216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6B4CF4-3EC9-4213-A168-B5FF11E57D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EF24E-8986-4213-878A-B70333F0BDF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7FF9A3-B42B-4301-8C30-D0E7772DBAB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94077C-1FC4-4B66-9434-D9D2F68D1A5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39DDA8-9250-472A-B0AD-28FCB24525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9F89D9-F6B2-49C8-8600-62354FA59D0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08677-5349-42D8-A5EC-1DD6F1E730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8B91F1-F8B8-42D4-96AC-01D5829B989D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5383A1-6872-4BDD-A0CA-8E5E7D54B27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64BF-A1DF-44DC-BB50-5C1B31AADA9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82968-46A5-49FB-843B-968C60F7B8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863F39-56A7-4BDD-9BDF-CE2ED9617389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3D7A67-603A-4443-B981-FED77F8B8BC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72829A-F9AD-4F85-8742-A7921280B49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E9FB66-E665-4ECA-B3BF-6757A74945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B7FD3-B99E-4187-9933-AC9AB1DB312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EA5B27-D46A-45E5-997E-51E74B173B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536B44-95B8-4C0A-995D-B6DA8903392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5727CC-AEDC-4499-97F7-F71B072ABA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4FE53-0901-46B4-BB33-B6E688B1B94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47EBED-B686-4F5E-AA92-8267F9708D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614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1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D707B30-B607-4830-AF03-751890073B6C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53FBA08-8B6C-4D0B-A2C0-C870076B75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ictureTable1D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6580" y="783522"/>
            <a:ext cx="8970179" cy="890897"/>
          </a:xfrm>
          <a:prstGeom prst="rect">
            <a:avLst/>
          </a:prstGeom>
        </p:spPr>
      </p:pic>
      <p:pic>
        <p:nvPicPr>
          <p:cNvPr id="5" name="Picture 4" descr="PictureTable1C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79617" y="2218571"/>
            <a:ext cx="7024109" cy="3362832"/>
          </a:xfrm>
          <a:prstGeom prst="rect">
            <a:avLst/>
          </a:prstGeom>
        </p:spPr>
      </p:pic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1079617" y="5910233"/>
            <a:ext cx="6958941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pPr eaLnBrk="0" hangingPunct="0">
              <a:tabLst>
                <a:tab pos="450850" algn="l"/>
              </a:tabLst>
            </a:pPr>
            <a:r>
              <a:rPr lang="en-US" sz="1000" b="1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Additional file 10: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Querying for the diurnal phase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of expression in a subset of rice genes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using PathVisio.</a:t>
            </a:r>
          </a:p>
          <a:p>
            <a:pPr eaLnBrk="0" hangingPunct="0">
              <a:tabLst>
                <a:tab pos="450850" algn="l"/>
              </a:tabLst>
            </a:pP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(A) Number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of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genes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that have a phase above 12 and display a diurnal crest in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dark. (B) Number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of </a:t>
            </a:r>
            <a:r>
              <a:rPr lang="en-US" sz="1000" dirty="0" smtClean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genes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up-regulated in the mid-day hours.      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61257" y="4393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83032" y="194554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92797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23&quot;&gt;&lt;property id=&quot;20148&quot; value=&quot;5&quot;/&gt;&lt;property id=&quot;20300&quot; value=&quot;Slide 1&quot;/&gt;&lt;property id=&quot;20307&quot; value=&quot;285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pex</Template>
  <TotalTime>11388</TotalTime>
  <Words>5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iswal Lab</dc:creator>
  <cp:lastModifiedBy>Real, Francis Frank</cp:lastModifiedBy>
  <cp:revision>542</cp:revision>
  <dcterms:created xsi:type="dcterms:W3CDTF">2012-03-13T21:10:20Z</dcterms:created>
  <dcterms:modified xsi:type="dcterms:W3CDTF">2013-06-11T10:46:23Z</dcterms:modified>
</cp:coreProperties>
</file>